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</p:sldIdLst>
  <p:sldSz cx="9144000" cy="6858000"/>
  <p:notesSz cx="7099300" cy="939958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F16BBC-7A9F-449B-87B7-942190A541F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02EBF0-F53B-468C-9743-231C19E337C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D0EA70-ACB1-4A5E-A02D-CD8C7A4D0D1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05B087-A5A5-4DAE-9AB2-009B3A25888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9EA9BB-EBD2-40F8-B1BC-5F6659AABAB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EB4155-01E8-402A-90DA-306011CF587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CF3527-66DA-45F7-88F5-2169F603EE1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EDBDDE-C811-492F-A4E0-52917148C30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DDB4D2-BEAC-49CB-9E0E-291C7BBEE86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495E0A-CDEC-4EA6-80C0-CB1CABFF8EC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946C2C-1153-4BBD-90DB-B46432AAA55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C76B15-D4D8-45B4-A0B5-E3DE139FAF4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594C5A5-F674-418B-B3DA-FEF6267DCCE1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image" Target="../media/image5.png"/><Relationship Id="rId3" Type="http://schemas.openxmlformats.org/officeDocument/2006/relationships/image" Target="../media/image6.png"/><Relationship Id="rId4" Type="http://schemas.openxmlformats.org/officeDocument/2006/relationships/image" Target="../media/image7.png"/><Relationship Id="rId5" Type="http://schemas.openxmlformats.org/officeDocument/2006/relationships/image" Target="../media/image8.png"/><Relationship Id="rId6" Type="http://schemas.openxmlformats.org/officeDocument/2006/relationships/image" Target="../media/image9.png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2978280" y="922320"/>
            <a:ext cx="1036440" cy="1440"/>
          </a:xfrm>
          <a:prstGeom prst="line">
            <a:avLst/>
          </a:prstGeom>
          <a:ln w="1260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2092320" y="3076560"/>
            <a:ext cx="4880160" cy="2649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upplementary Figure 1.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SimSun"/>
              </a:rPr>
              <a:t>Determination of TRAP expression in alveolar bone at tooth extraction sockets in C57BL/6 mice. Mice (B6) were treated with Zol (Z) and Dex (D) [B6/Z(+)D(+)], whereby mice with no treatment [B6/Z(-)D(-)] were served as controls. At 7 weeks post tooth extraction, the expression of TRAP in tooth extraction sockets was determined by immunostaining with a specific antibody for mice TRAP (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SimSun"/>
              </a:rPr>
              <a:t>A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SimSun"/>
              </a:rPr>
              <a:t>). BnxZ(+)D(+) mice were treated with intravenous infusion of either T cells [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SimSun"/>
              </a:rPr>
              <a:t>Bnx/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SimSun"/>
              </a:rPr>
              <a:t>Z(+)D(+)T], or T cells with depleted Tregs [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SimSun"/>
              </a:rPr>
              <a:t>Bnx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SimSun"/>
              </a:rPr>
              <a:t>/Z(+)D(+)T(-Treg)], or purified Tregs [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SimSun"/>
              </a:rPr>
              <a:t>Bnx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SimSun"/>
              </a:rPr>
              <a:t>/Z(+)D(+)Treg] were included. Mice with no treatment [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SimSun"/>
              </a:rPr>
              <a:t>Bnx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SimSun"/>
              </a:rPr>
              <a:t>/Z(-)D(-)] were served as controls.  At 7 weeks post tooth extraction, the expression of TRAP in tooth extraction sockets was determined by immunostaining with a specific antibody for mice TRAP (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SimSun"/>
              </a:rPr>
              <a:t>B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SimSun"/>
              </a:rPr>
              <a:t>). *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SimSun"/>
              </a:rPr>
              <a:t>P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SimSun"/>
              </a:rPr>
              <a:t>&lt;0.05, **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SimSun"/>
              </a:rPr>
              <a:t>P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SimSun"/>
              </a:rPr>
              <a:t>&lt;0.01, ***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SimSun"/>
              </a:rPr>
              <a:t>P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SimSun"/>
              </a:rPr>
              <a:t>&lt;0.005. The results were representative of three independent experiment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3" name=""/>
          <p:cNvGrpSpPr/>
          <p:nvPr/>
        </p:nvGrpSpPr>
        <p:grpSpPr>
          <a:xfrm>
            <a:off x="3957480" y="542880"/>
            <a:ext cx="2004840" cy="2716200"/>
            <a:chOff x="3957480" y="542880"/>
            <a:chExt cx="2004840" cy="2716200"/>
          </a:xfrm>
        </p:grpSpPr>
        <p:sp>
          <p:nvSpPr>
            <p:cNvPr id="44" name=""/>
            <p:cNvSpPr/>
            <p:nvPr/>
          </p:nvSpPr>
          <p:spPr>
            <a:xfrm>
              <a:off x="3957480" y="542880"/>
              <a:ext cx="290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SimSun"/>
                </a:rPr>
                <a:t>B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4146480" y="901800"/>
              <a:ext cx="1654200" cy="1474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4552920" y="1095480"/>
              <a:ext cx="1150920" cy="10843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4552920" y="1638360"/>
              <a:ext cx="1150920" cy="1440"/>
            </a:xfrm>
            <a:prstGeom prst="line">
              <a:avLst/>
            </a:prstGeom>
            <a:ln w="324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4552920" y="1095480"/>
              <a:ext cx="1150920" cy="1440"/>
            </a:xfrm>
            <a:prstGeom prst="line">
              <a:avLst/>
            </a:prstGeom>
            <a:ln w="324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4589640" y="1814400"/>
              <a:ext cx="155520" cy="3654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4594320" y="1819440"/>
              <a:ext cx="145800" cy="355320"/>
            </a:xfrm>
            <a:prstGeom prst="rect">
              <a:avLst/>
            </a:prstGeom>
            <a:noFill/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4821120" y="2025720"/>
              <a:ext cx="154080" cy="1540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4826160" y="2030400"/>
              <a:ext cx="144360" cy="144360"/>
            </a:xfrm>
            <a:prstGeom prst="rect">
              <a:avLst/>
            </a:prstGeom>
            <a:noFill/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5051520" y="2071800"/>
              <a:ext cx="153720" cy="1080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5056200" y="2076480"/>
              <a:ext cx="144360" cy="98280"/>
            </a:xfrm>
            <a:prstGeom prst="rect">
              <a:avLst/>
            </a:prstGeom>
            <a:noFill/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5281560" y="1949400"/>
              <a:ext cx="154080" cy="2304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5286240" y="1954080"/>
              <a:ext cx="144720" cy="220680"/>
            </a:xfrm>
            <a:prstGeom prst="rect">
              <a:avLst/>
            </a:prstGeom>
            <a:noFill/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5511960" y="1603440"/>
              <a:ext cx="153720" cy="5763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5516640" y="1608120"/>
              <a:ext cx="144360" cy="566640"/>
            </a:xfrm>
            <a:prstGeom prst="rect">
              <a:avLst/>
            </a:prstGeom>
            <a:noFill/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 flipV="1">
              <a:off x="4665600" y="1744560"/>
              <a:ext cx="1800" cy="6984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4627440" y="1744560"/>
              <a:ext cx="79560" cy="180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4665600" y="1814400"/>
              <a:ext cx="1800" cy="6696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4627440" y="1881360"/>
              <a:ext cx="79560" cy="144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 flipV="1">
              <a:off x="4896000" y="1971720"/>
              <a:ext cx="1440" cy="5400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0" bIns="7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4857840" y="1971720"/>
              <a:ext cx="79200" cy="144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4896000" y="2025720"/>
              <a:ext cx="1440" cy="5220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4857840" y="2077920"/>
              <a:ext cx="79200" cy="180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 flipV="1">
              <a:off x="5126040" y="2053800"/>
              <a:ext cx="1440" cy="1764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160" bIns="-291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5089680" y="2054160"/>
              <a:ext cx="77760" cy="180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5126040" y="2071800"/>
              <a:ext cx="1440" cy="2052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5089680" y="2092320"/>
              <a:ext cx="77760" cy="144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 flipV="1">
              <a:off x="5357880" y="1916280"/>
              <a:ext cx="1440" cy="3312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5319720" y="1916280"/>
              <a:ext cx="77760" cy="144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5357880" y="1949400"/>
              <a:ext cx="1440" cy="3168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5319720" y="1981080"/>
              <a:ext cx="77760" cy="180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 flipV="1">
              <a:off x="5587920" y="1463760"/>
              <a:ext cx="1800" cy="13968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5549760" y="1463760"/>
              <a:ext cx="77760" cy="144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5587920" y="1603440"/>
              <a:ext cx="1800" cy="14436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5549760" y="1747800"/>
              <a:ext cx="77760" cy="180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4552920" y="1095480"/>
              <a:ext cx="1440" cy="108432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4518000" y="2179800"/>
              <a:ext cx="34920" cy="144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4518000" y="1638360"/>
              <a:ext cx="34920" cy="144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4518000" y="1095480"/>
              <a:ext cx="34920" cy="144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4552920" y="2179800"/>
              <a:ext cx="1150920" cy="144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 flipV="1">
              <a:off x="4552920" y="2179800"/>
              <a:ext cx="1440" cy="288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 flipV="1">
              <a:off x="5703840" y="2179800"/>
              <a:ext cx="1800" cy="288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4435560" y="210348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4387680" y="157176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5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4327560" y="1047600"/>
              <a:ext cx="169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5126040" y="2195640"/>
              <a:ext cx="8280" cy="15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" spc="-1" strike="noStrike">
                  <a:solidFill>
                    <a:srgbClr val="000000"/>
                  </a:solidFill>
                  <a:latin typeface="Verdana"/>
                </a:rPr>
                <a:t>1</a:t>
              </a:r>
              <a:endParaRPr b="0" lang="en-US" sz="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"/>
            <p:cNvSpPr/>
            <p:nvPr/>
          </p:nvSpPr>
          <p:spPr>
            <a:xfrm rot="18462000">
              <a:off x="3985920" y="2400120"/>
              <a:ext cx="901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SimSun"/>
                </a:rPr>
                <a:t>Bnx/Z(-)D(-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"/>
            <p:cNvSpPr/>
            <p:nvPr/>
          </p:nvSpPr>
          <p:spPr>
            <a:xfrm rot="18469200">
              <a:off x="4215600" y="2398680"/>
              <a:ext cx="1008000" cy="400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SimSun"/>
                </a:rPr>
                <a:t>Bnx/Z(+)D(+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"/>
            <p:cNvSpPr/>
            <p:nvPr/>
          </p:nvSpPr>
          <p:spPr>
            <a:xfrm rot="18447000">
              <a:off x="4204440" y="2556720"/>
              <a:ext cx="1230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SimSun"/>
                </a:rPr>
                <a:t>Bnx/Z(+)D(+)T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"/>
            <p:cNvSpPr/>
            <p:nvPr/>
          </p:nvSpPr>
          <p:spPr>
            <a:xfrm rot="18447000">
              <a:off x="4792320" y="2437560"/>
              <a:ext cx="1257120" cy="400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SimSun"/>
                </a:rPr>
                <a:t>Bnx/Z(+)D(+)Treg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"/>
            <p:cNvSpPr/>
            <p:nvPr/>
          </p:nvSpPr>
          <p:spPr>
            <a:xfrm flipV="1">
              <a:off x="5545080" y="1317600"/>
              <a:ext cx="0" cy="76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"/>
            <p:cNvSpPr/>
            <p:nvPr/>
          </p:nvSpPr>
          <p:spPr>
            <a:xfrm flipV="1">
              <a:off x="5392800" y="1317600"/>
              <a:ext cx="0" cy="533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"/>
            <p:cNvSpPr/>
            <p:nvPr/>
          </p:nvSpPr>
          <p:spPr>
            <a:xfrm>
              <a:off x="5392800" y="1317600"/>
              <a:ext cx="1522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"/>
            <p:cNvSpPr/>
            <p:nvPr/>
          </p:nvSpPr>
          <p:spPr>
            <a:xfrm flipV="1">
              <a:off x="5316480" y="1622160"/>
              <a:ext cx="0" cy="2286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"/>
            <p:cNvSpPr/>
            <p:nvPr/>
          </p:nvSpPr>
          <p:spPr>
            <a:xfrm flipV="1">
              <a:off x="5164200" y="1622520"/>
              <a:ext cx="0" cy="380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"/>
            <p:cNvSpPr/>
            <p:nvPr/>
          </p:nvSpPr>
          <p:spPr>
            <a:xfrm>
              <a:off x="5164200" y="1622520"/>
              <a:ext cx="1522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"/>
            <p:cNvSpPr/>
            <p:nvPr/>
          </p:nvSpPr>
          <p:spPr>
            <a:xfrm flipV="1">
              <a:off x="4935600" y="1622520"/>
              <a:ext cx="0" cy="3045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"/>
            <p:cNvSpPr/>
            <p:nvPr/>
          </p:nvSpPr>
          <p:spPr>
            <a:xfrm flipV="1">
              <a:off x="5087880" y="1622520"/>
              <a:ext cx="0" cy="380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"/>
            <p:cNvSpPr/>
            <p:nvPr/>
          </p:nvSpPr>
          <p:spPr>
            <a:xfrm>
              <a:off x="4935600" y="1622520"/>
              <a:ext cx="1522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"/>
            <p:cNvSpPr/>
            <p:nvPr/>
          </p:nvSpPr>
          <p:spPr>
            <a:xfrm flipV="1">
              <a:off x="5316480" y="1469880"/>
              <a:ext cx="0" cy="76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"/>
            <p:cNvSpPr/>
            <p:nvPr/>
          </p:nvSpPr>
          <p:spPr>
            <a:xfrm flipV="1">
              <a:off x="4935600" y="1469880"/>
              <a:ext cx="0" cy="76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"/>
            <p:cNvSpPr/>
            <p:nvPr/>
          </p:nvSpPr>
          <p:spPr>
            <a:xfrm>
              <a:off x="4935600" y="1469880"/>
              <a:ext cx="3808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"/>
            <p:cNvSpPr/>
            <p:nvPr/>
          </p:nvSpPr>
          <p:spPr>
            <a:xfrm flipV="1">
              <a:off x="4707000" y="1469520"/>
              <a:ext cx="0" cy="2286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"/>
            <p:cNvSpPr/>
            <p:nvPr/>
          </p:nvSpPr>
          <p:spPr>
            <a:xfrm flipV="1">
              <a:off x="4859280" y="1469880"/>
              <a:ext cx="0" cy="457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"/>
            <p:cNvSpPr/>
            <p:nvPr/>
          </p:nvSpPr>
          <p:spPr>
            <a:xfrm>
              <a:off x="4707000" y="1469880"/>
              <a:ext cx="1522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"/>
            <p:cNvSpPr/>
            <p:nvPr/>
          </p:nvSpPr>
          <p:spPr>
            <a:xfrm flipV="1">
              <a:off x="4707000" y="1317600"/>
              <a:ext cx="0" cy="76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"/>
            <p:cNvSpPr/>
            <p:nvPr/>
          </p:nvSpPr>
          <p:spPr>
            <a:xfrm flipV="1">
              <a:off x="5087880" y="1317600"/>
              <a:ext cx="0" cy="76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"/>
            <p:cNvSpPr/>
            <p:nvPr/>
          </p:nvSpPr>
          <p:spPr>
            <a:xfrm>
              <a:off x="4707000" y="1317600"/>
              <a:ext cx="3808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"/>
            <p:cNvSpPr/>
            <p:nvPr/>
          </p:nvSpPr>
          <p:spPr>
            <a:xfrm flipV="1">
              <a:off x="4707000" y="860400"/>
              <a:ext cx="0" cy="380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"/>
            <p:cNvSpPr/>
            <p:nvPr/>
          </p:nvSpPr>
          <p:spPr>
            <a:xfrm flipV="1">
              <a:off x="5164200" y="1164960"/>
              <a:ext cx="0" cy="2286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"/>
            <p:cNvSpPr/>
            <p:nvPr/>
          </p:nvSpPr>
          <p:spPr>
            <a:xfrm>
              <a:off x="4707000" y="708120"/>
              <a:ext cx="8380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"/>
            <p:cNvSpPr/>
            <p:nvPr/>
          </p:nvSpPr>
          <p:spPr>
            <a:xfrm flipV="1">
              <a:off x="5545080" y="1164960"/>
              <a:ext cx="0" cy="75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"/>
            <p:cNvSpPr/>
            <p:nvPr/>
          </p:nvSpPr>
          <p:spPr>
            <a:xfrm>
              <a:off x="5164200" y="1165320"/>
              <a:ext cx="3808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"/>
            <p:cNvSpPr/>
            <p:nvPr/>
          </p:nvSpPr>
          <p:spPr>
            <a:xfrm>
              <a:off x="4707000" y="860400"/>
              <a:ext cx="6094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"/>
            <p:cNvSpPr/>
            <p:nvPr/>
          </p:nvSpPr>
          <p:spPr>
            <a:xfrm>
              <a:off x="4935600" y="1012680"/>
              <a:ext cx="6094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"/>
            <p:cNvSpPr/>
            <p:nvPr/>
          </p:nvSpPr>
          <p:spPr>
            <a:xfrm flipV="1">
              <a:off x="4935600" y="1012320"/>
              <a:ext cx="0" cy="2286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"/>
            <p:cNvSpPr/>
            <p:nvPr/>
          </p:nvSpPr>
          <p:spPr>
            <a:xfrm flipV="1">
              <a:off x="5545080" y="1012680"/>
              <a:ext cx="0" cy="76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"/>
            <p:cNvSpPr/>
            <p:nvPr/>
          </p:nvSpPr>
          <p:spPr>
            <a:xfrm flipV="1">
              <a:off x="5316480" y="860400"/>
              <a:ext cx="0" cy="76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"/>
            <p:cNvSpPr/>
            <p:nvPr/>
          </p:nvSpPr>
          <p:spPr>
            <a:xfrm flipV="1">
              <a:off x="4707000" y="707760"/>
              <a:ext cx="0" cy="75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"/>
            <p:cNvSpPr/>
            <p:nvPr/>
          </p:nvSpPr>
          <p:spPr>
            <a:xfrm flipV="1">
              <a:off x="5545080" y="707760"/>
              <a:ext cx="0" cy="2286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"/>
            <p:cNvSpPr/>
            <p:nvPr/>
          </p:nvSpPr>
          <p:spPr>
            <a:xfrm>
              <a:off x="4648320" y="1343160"/>
              <a:ext cx="299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***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"/>
            <p:cNvSpPr/>
            <p:nvPr/>
          </p:nvSpPr>
          <p:spPr>
            <a:xfrm>
              <a:off x="4781880" y="1190520"/>
              <a:ext cx="299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***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"/>
            <p:cNvSpPr/>
            <p:nvPr/>
          </p:nvSpPr>
          <p:spPr>
            <a:xfrm>
              <a:off x="4929480" y="743040"/>
              <a:ext cx="259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**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"/>
            <p:cNvSpPr/>
            <p:nvPr/>
          </p:nvSpPr>
          <p:spPr>
            <a:xfrm>
              <a:off x="5043600" y="581040"/>
              <a:ext cx="259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**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"/>
            <p:cNvSpPr/>
            <p:nvPr/>
          </p:nvSpPr>
          <p:spPr>
            <a:xfrm>
              <a:off x="4923000" y="1504800"/>
              <a:ext cx="220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"/>
            <p:cNvSpPr/>
            <p:nvPr/>
          </p:nvSpPr>
          <p:spPr>
            <a:xfrm>
              <a:off x="5037120" y="1352520"/>
              <a:ext cx="220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"/>
            <p:cNvSpPr/>
            <p:nvPr/>
          </p:nvSpPr>
          <p:spPr>
            <a:xfrm>
              <a:off x="5077080" y="895320"/>
              <a:ext cx="299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***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"/>
            <p:cNvSpPr/>
            <p:nvPr/>
          </p:nvSpPr>
          <p:spPr>
            <a:xfrm>
              <a:off x="5239080" y="1038240"/>
              <a:ext cx="299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***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"/>
            <p:cNvSpPr/>
            <p:nvPr/>
          </p:nvSpPr>
          <p:spPr>
            <a:xfrm>
              <a:off x="5105520" y="1504800"/>
              <a:ext cx="299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***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"/>
            <p:cNvSpPr/>
            <p:nvPr/>
          </p:nvSpPr>
          <p:spPr>
            <a:xfrm>
              <a:off x="5353200" y="1181160"/>
              <a:ext cx="220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"/>
            <p:cNvSpPr/>
            <p:nvPr/>
          </p:nvSpPr>
          <p:spPr>
            <a:xfrm>
              <a:off x="4518000" y="1362240"/>
              <a:ext cx="34920" cy="144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"/>
            <p:cNvSpPr/>
            <p:nvPr/>
          </p:nvSpPr>
          <p:spPr>
            <a:xfrm>
              <a:off x="4508640" y="1933560"/>
              <a:ext cx="34920" cy="144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"/>
            <p:cNvSpPr/>
            <p:nvPr/>
          </p:nvSpPr>
          <p:spPr>
            <a:xfrm>
              <a:off x="4387680" y="187632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2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"/>
            <p:cNvSpPr/>
            <p:nvPr/>
          </p:nvSpPr>
          <p:spPr>
            <a:xfrm>
              <a:off x="4387680" y="130500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7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"/>
            <p:cNvSpPr/>
            <p:nvPr/>
          </p:nvSpPr>
          <p:spPr>
            <a:xfrm rot="16200000">
              <a:off x="3738240" y="1456200"/>
              <a:ext cx="8740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SimSun"/>
                </a:rPr>
                <a:t>TRAP</a:t>
              </a:r>
              <a:r>
                <a:rPr b="0" lang="en-US" sz="800" spc="-1" strike="noStrike" baseline="30000">
                  <a:solidFill>
                    <a:srgbClr val="000000"/>
                  </a:solidFill>
                  <a:latin typeface="Arial"/>
                  <a:ea typeface="SimSun"/>
                </a:rPr>
                <a:t>+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SimSun"/>
                </a:rPr>
                <a:t> CELL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SimSun"/>
                </a:rPr>
                <a:t>(/BONE AREA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39" name=""/>
          <p:cNvSpPr/>
          <p:nvPr/>
        </p:nvSpPr>
        <p:spPr>
          <a:xfrm rot="18450600">
            <a:off x="4428360" y="2481120"/>
            <a:ext cx="1493640" cy="40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SimSun"/>
              </a:rPr>
              <a:t>Bnx/Z(+)D(+)T(-Treg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40" name=""/>
          <p:cNvGrpSpPr/>
          <p:nvPr/>
        </p:nvGrpSpPr>
        <p:grpSpPr>
          <a:xfrm>
            <a:off x="2405160" y="560520"/>
            <a:ext cx="1351800" cy="2284200"/>
            <a:chOff x="2405160" y="560520"/>
            <a:chExt cx="1351800" cy="2284200"/>
          </a:xfrm>
        </p:grpSpPr>
        <p:sp>
          <p:nvSpPr>
            <p:cNvPr id="141" name=""/>
            <p:cNvSpPr/>
            <p:nvPr/>
          </p:nvSpPr>
          <p:spPr>
            <a:xfrm>
              <a:off x="3021120" y="1763640"/>
              <a:ext cx="172800" cy="21276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"/>
            <p:cNvSpPr/>
            <p:nvPr/>
          </p:nvSpPr>
          <p:spPr>
            <a:xfrm>
              <a:off x="3014640" y="1757520"/>
              <a:ext cx="173160" cy="21420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"/>
            <p:cNvSpPr/>
            <p:nvPr/>
          </p:nvSpPr>
          <p:spPr>
            <a:xfrm>
              <a:off x="3540240" y="1909800"/>
              <a:ext cx="174600" cy="666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"/>
            <p:cNvSpPr/>
            <p:nvPr/>
          </p:nvSpPr>
          <p:spPr>
            <a:xfrm>
              <a:off x="3354480" y="1895400"/>
              <a:ext cx="172800" cy="810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200" bIns="34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"/>
            <p:cNvSpPr/>
            <p:nvPr/>
          </p:nvSpPr>
          <p:spPr>
            <a:xfrm>
              <a:off x="3348000" y="1889280"/>
              <a:ext cx="174600" cy="8244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5640" bIns="35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"/>
            <p:cNvSpPr/>
            <p:nvPr/>
          </p:nvSpPr>
          <p:spPr>
            <a:xfrm flipV="1">
              <a:off x="3100320" y="1650960"/>
              <a:ext cx="1800" cy="1065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"/>
            <p:cNvSpPr/>
            <p:nvPr/>
          </p:nvSpPr>
          <p:spPr>
            <a:xfrm>
              <a:off x="3060720" y="1650960"/>
              <a:ext cx="8100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"/>
            <p:cNvSpPr/>
            <p:nvPr/>
          </p:nvSpPr>
          <p:spPr>
            <a:xfrm flipV="1">
              <a:off x="3433680" y="1860480"/>
              <a:ext cx="1800" cy="28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"/>
            <p:cNvSpPr/>
            <p:nvPr/>
          </p:nvSpPr>
          <p:spPr>
            <a:xfrm>
              <a:off x="3394080" y="1860480"/>
              <a:ext cx="8244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"/>
            <p:cNvSpPr/>
            <p:nvPr/>
          </p:nvSpPr>
          <p:spPr>
            <a:xfrm>
              <a:off x="3433680" y="1889280"/>
              <a:ext cx="1800" cy="270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800" bIns="-19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"/>
            <p:cNvSpPr/>
            <p:nvPr/>
          </p:nvSpPr>
          <p:spPr>
            <a:xfrm>
              <a:off x="3394080" y="1916280"/>
              <a:ext cx="8244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"/>
            <p:cNvSpPr/>
            <p:nvPr/>
          </p:nvSpPr>
          <p:spPr>
            <a:xfrm>
              <a:off x="2971800" y="915840"/>
              <a:ext cx="1440" cy="10558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"/>
            <p:cNvSpPr/>
            <p:nvPr/>
          </p:nvSpPr>
          <p:spPr>
            <a:xfrm>
              <a:off x="2935440" y="1971720"/>
              <a:ext cx="3636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"/>
            <p:cNvSpPr/>
            <p:nvPr/>
          </p:nvSpPr>
          <p:spPr>
            <a:xfrm>
              <a:off x="2971800" y="1971720"/>
              <a:ext cx="63972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"/>
            <p:cNvSpPr/>
            <p:nvPr/>
          </p:nvSpPr>
          <p:spPr>
            <a:xfrm flipV="1">
              <a:off x="2971800" y="1971360"/>
              <a:ext cx="1440" cy="32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"/>
            <p:cNvSpPr/>
            <p:nvPr/>
          </p:nvSpPr>
          <p:spPr>
            <a:xfrm flipV="1">
              <a:off x="3564000" y="1971360"/>
              <a:ext cx="1440" cy="32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"/>
            <p:cNvSpPr/>
            <p:nvPr/>
          </p:nvSpPr>
          <p:spPr>
            <a:xfrm>
              <a:off x="2817720" y="190188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"/>
            <p:cNvSpPr/>
            <p:nvPr/>
          </p:nvSpPr>
          <p:spPr>
            <a:xfrm>
              <a:off x="2814480" y="137304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5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"/>
            <p:cNvSpPr/>
            <p:nvPr/>
          </p:nvSpPr>
          <p:spPr>
            <a:xfrm>
              <a:off x="3495600" y="1992240"/>
              <a:ext cx="8280" cy="15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" spc="-1" strike="noStrike">
                  <a:solidFill>
                    <a:srgbClr val="000000"/>
                  </a:solidFill>
                  <a:latin typeface="Verdana"/>
                </a:rPr>
                <a:t>1</a:t>
              </a:r>
              <a:endParaRPr b="0" lang="en-US" sz="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"/>
            <p:cNvSpPr/>
            <p:nvPr/>
          </p:nvSpPr>
          <p:spPr>
            <a:xfrm rot="18938400">
              <a:off x="2430000" y="2131560"/>
              <a:ext cx="868320" cy="400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SimSun"/>
                </a:rPr>
                <a:t>B6/Z(-)D(-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"/>
            <p:cNvSpPr/>
            <p:nvPr/>
          </p:nvSpPr>
          <p:spPr>
            <a:xfrm rot="18952800">
              <a:off x="2804760" y="2171160"/>
              <a:ext cx="946080" cy="400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SimSun"/>
                </a:rPr>
                <a:t>B6/Z(+)D(+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"/>
            <p:cNvSpPr/>
            <p:nvPr/>
          </p:nvSpPr>
          <p:spPr>
            <a:xfrm rot="16200000">
              <a:off x="2136600" y="1373760"/>
              <a:ext cx="8740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SimSun"/>
                </a:rPr>
                <a:t>TRAP</a:t>
              </a:r>
              <a:r>
                <a:rPr b="0" lang="en-US" sz="800" spc="-1" strike="noStrike" baseline="30000">
                  <a:solidFill>
                    <a:srgbClr val="000000"/>
                  </a:solidFill>
                  <a:latin typeface="Arial"/>
                  <a:ea typeface="SimSun"/>
                </a:rPr>
                <a:t>+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SimSun"/>
                </a:rPr>
                <a:t> CELL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SimSun"/>
                </a:rPr>
                <a:t>(/BONE AREA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"/>
            <p:cNvSpPr/>
            <p:nvPr/>
          </p:nvSpPr>
          <p:spPr>
            <a:xfrm flipV="1">
              <a:off x="3095640" y="1422360"/>
              <a:ext cx="0" cy="76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"/>
            <p:cNvSpPr/>
            <p:nvPr/>
          </p:nvSpPr>
          <p:spPr>
            <a:xfrm>
              <a:off x="3189240" y="1276200"/>
              <a:ext cx="223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"/>
            <p:cNvSpPr/>
            <p:nvPr/>
          </p:nvSpPr>
          <p:spPr>
            <a:xfrm>
              <a:off x="2438280" y="560520"/>
              <a:ext cx="290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SimSun"/>
                </a:rPr>
                <a:t>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"/>
            <p:cNvSpPr/>
            <p:nvPr/>
          </p:nvSpPr>
          <p:spPr>
            <a:xfrm>
              <a:off x="2933640" y="1428840"/>
              <a:ext cx="288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"/>
            <p:cNvSpPr/>
            <p:nvPr/>
          </p:nvSpPr>
          <p:spPr>
            <a:xfrm>
              <a:off x="2943360" y="933480"/>
              <a:ext cx="284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"/>
            <p:cNvSpPr/>
            <p:nvPr/>
          </p:nvSpPr>
          <p:spPr>
            <a:xfrm>
              <a:off x="2757600" y="878040"/>
              <a:ext cx="169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"/>
            <p:cNvSpPr/>
            <p:nvPr/>
          </p:nvSpPr>
          <p:spPr>
            <a:xfrm>
              <a:off x="3105000" y="1419120"/>
              <a:ext cx="3430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"/>
            <p:cNvSpPr/>
            <p:nvPr/>
          </p:nvSpPr>
          <p:spPr>
            <a:xfrm>
              <a:off x="3448080" y="1428840"/>
              <a:ext cx="0" cy="285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1" name=""/>
          <p:cNvSpPr/>
          <p:nvPr/>
        </p:nvSpPr>
        <p:spPr>
          <a:xfrm>
            <a:off x="1473120" y="2901960"/>
            <a:ext cx="5529240" cy="2101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upplementary Figure 2.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SimSun"/>
              </a:rPr>
              <a:t>Effect of tooth extraction on the levels of Tregs and Th17 in Zol and Dex treated C57BL/6J mice by flow cytometry.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SimSu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SimSun"/>
              </a:rPr>
              <a:t>Mice (BL/6) with (+) or without (-) tooth extraction were treated with Zol (Z) and  Dex (D) [ [B6/Z(+)D(+)] for 2 weeks, whereby mice with no treatment [B6/Z(-)D(-)] were served as controls. (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SimSun"/>
              </a:rPr>
              <a:t>A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SimSun"/>
              </a:rPr>
              <a:t>) Tregs in CD4</a:t>
            </a: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  <a:ea typeface="SimSun"/>
              </a:rPr>
              <a:t>+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SimSun"/>
              </a:rPr>
              <a:t>PBMNCs were determined by flow cytometry after immunostaining of PBMNCs with APC-CD25/PerCP-CD4/FITC-Foxp3 antibodies. (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SimSun"/>
              </a:rPr>
              <a:t>B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SimSun"/>
              </a:rPr>
              <a:t>) Th17 were determined by flow cytometry after immunostaining of PCD4</a:t>
            </a: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  <a:ea typeface="SimSun"/>
              </a:rPr>
              <a:t>+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SimSun"/>
              </a:rPr>
              <a:t>BMNCs with PerCP-CD4/PE-IL17FITC-INF-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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SimSun"/>
              </a:rPr>
              <a:t> antibodies. (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SimSun"/>
              </a:rPr>
              <a:t>C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SimSun"/>
              </a:rPr>
              <a:t>) Tooth extraction reduce the ratio in Zol/Dex-treated group [B6/Z(+)D(+)]. **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SimSun"/>
              </a:rPr>
              <a:t>P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SimSun"/>
              </a:rPr>
              <a:t>&lt;0.05, ***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SimSun"/>
              </a:rPr>
              <a:t>P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SimSun"/>
              </a:rPr>
              <a:t>&lt;0.005. The results were representative of three independent experiment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"/>
          <p:cNvSpPr/>
          <p:nvPr/>
        </p:nvSpPr>
        <p:spPr>
          <a:xfrm>
            <a:off x="2064960" y="749160"/>
            <a:ext cx="1593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SimSun"/>
              </a:rPr>
              <a:t>BL/6 TOOTH EXTRACTION (-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"/>
          <p:cNvSpPr/>
          <p:nvPr/>
        </p:nvSpPr>
        <p:spPr>
          <a:xfrm>
            <a:off x="2064600" y="901800"/>
            <a:ext cx="1619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SimSun"/>
              </a:rPr>
              <a:t>BL/6 TOOTH EXTRACTION (+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"/>
          <p:cNvSpPr/>
          <p:nvPr/>
        </p:nvSpPr>
        <p:spPr>
          <a:xfrm>
            <a:off x="2170080" y="1433520"/>
            <a:ext cx="2023920" cy="1440"/>
          </a:xfrm>
          <a:prstGeom prst="line">
            <a:avLst/>
          </a:prstGeom>
          <a:ln w="1260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"/>
          <p:cNvSpPr/>
          <p:nvPr/>
        </p:nvSpPr>
        <p:spPr>
          <a:xfrm>
            <a:off x="4943520" y="1420920"/>
            <a:ext cx="2093760" cy="1440"/>
          </a:xfrm>
          <a:prstGeom prst="line">
            <a:avLst/>
          </a:prstGeom>
          <a:ln w="1260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76" name=""/>
          <p:cNvGrpSpPr/>
          <p:nvPr/>
        </p:nvGrpSpPr>
        <p:grpSpPr>
          <a:xfrm>
            <a:off x="1573200" y="812880"/>
            <a:ext cx="1733400" cy="2194200"/>
            <a:chOff x="1573200" y="812880"/>
            <a:chExt cx="1733400" cy="2194200"/>
          </a:xfrm>
        </p:grpSpPr>
        <p:sp>
          <p:nvSpPr>
            <p:cNvPr id="177" name=""/>
            <p:cNvSpPr/>
            <p:nvPr/>
          </p:nvSpPr>
          <p:spPr>
            <a:xfrm>
              <a:off x="1930320" y="812880"/>
              <a:ext cx="76320" cy="7596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160" bIns="291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"/>
            <p:cNvSpPr/>
            <p:nvPr/>
          </p:nvSpPr>
          <p:spPr>
            <a:xfrm>
              <a:off x="1930320" y="965160"/>
              <a:ext cx="76320" cy="763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"/>
            <p:cNvSpPr/>
            <p:nvPr/>
          </p:nvSpPr>
          <p:spPr>
            <a:xfrm rot="18182400">
              <a:off x="1931760" y="2442960"/>
              <a:ext cx="6714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SimSun"/>
                </a:rPr>
                <a:t>B6/Z(-)D(-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" name=""/>
            <p:cNvSpPr/>
            <p:nvPr/>
          </p:nvSpPr>
          <p:spPr>
            <a:xfrm rot="18187800">
              <a:off x="2449800" y="2537280"/>
              <a:ext cx="723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SimSun"/>
                </a:rPr>
                <a:t>B6/Z(+)D(+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"/>
            <p:cNvSpPr/>
            <p:nvPr/>
          </p:nvSpPr>
          <p:spPr>
            <a:xfrm>
              <a:off x="2290680" y="2000160"/>
              <a:ext cx="162000" cy="3510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" name=""/>
            <p:cNvSpPr/>
            <p:nvPr/>
          </p:nvSpPr>
          <p:spPr>
            <a:xfrm>
              <a:off x="2286000" y="1994040"/>
              <a:ext cx="160200" cy="35064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"/>
            <p:cNvSpPr/>
            <p:nvPr/>
          </p:nvSpPr>
          <p:spPr>
            <a:xfrm>
              <a:off x="2452680" y="2058840"/>
              <a:ext cx="163440" cy="2923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"/>
            <p:cNvSpPr/>
            <p:nvPr/>
          </p:nvSpPr>
          <p:spPr>
            <a:xfrm>
              <a:off x="2446200" y="2052720"/>
              <a:ext cx="163800" cy="29196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" name=""/>
            <p:cNvSpPr/>
            <p:nvPr/>
          </p:nvSpPr>
          <p:spPr>
            <a:xfrm>
              <a:off x="2938320" y="1866960"/>
              <a:ext cx="162000" cy="4842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" name=""/>
            <p:cNvSpPr/>
            <p:nvPr/>
          </p:nvSpPr>
          <p:spPr>
            <a:xfrm>
              <a:off x="2779560" y="2182680"/>
              <a:ext cx="163800" cy="1684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" name=""/>
            <p:cNvSpPr/>
            <p:nvPr/>
          </p:nvSpPr>
          <p:spPr>
            <a:xfrm>
              <a:off x="2773440" y="2176560"/>
              <a:ext cx="163440" cy="16812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" name=""/>
            <p:cNvSpPr/>
            <p:nvPr/>
          </p:nvSpPr>
          <p:spPr>
            <a:xfrm>
              <a:off x="2943360" y="2119320"/>
              <a:ext cx="161640" cy="2318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9" name=""/>
            <p:cNvSpPr/>
            <p:nvPr/>
          </p:nvSpPr>
          <p:spPr>
            <a:xfrm>
              <a:off x="2936880" y="2112840"/>
              <a:ext cx="162000" cy="23184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" name=""/>
            <p:cNvSpPr/>
            <p:nvPr/>
          </p:nvSpPr>
          <p:spPr>
            <a:xfrm flipV="1">
              <a:off x="2363760" y="1963800"/>
              <a:ext cx="1440" cy="302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"/>
            <p:cNvSpPr/>
            <p:nvPr/>
          </p:nvSpPr>
          <p:spPr>
            <a:xfrm>
              <a:off x="2324160" y="1963800"/>
              <a:ext cx="8244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"/>
            <p:cNvSpPr/>
            <p:nvPr/>
          </p:nvSpPr>
          <p:spPr>
            <a:xfrm>
              <a:off x="2363760" y="1994040"/>
              <a:ext cx="1440" cy="298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" name=""/>
            <p:cNvSpPr/>
            <p:nvPr/>
          </p:nvSpPr>
          <p:spPr>
            <a:xfrm>
              <a:off x="2324160" y="2023920"/>
              <a:ext cx="8244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" name=""/>
            <p:cNvSpPr/>
            <p:nvPr/>
          </p:nvSpPr>
          <p:spPr>
            <a:xfrm flipV="1">
              <a:off x="2525760" y="2030400"/>
              <a:ext cx="1440" cy="223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5" name=""/>
            <p:cNvSpPr/>
            <p:nvPr/>
          </p:nvSpPr>
          <p:spPr>
            <a:xfrm>
              <a:off x="2486160" y="2030400"/>
              <a:ext cx="8244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6" name=""/>
            <p:cNvSpPr/>
            <p:nvPr/>
          </p:nvSpPr>
          <p:spPr>
            <a:xfrm>
              <a:off x="2525760" y="2052720"/>
              <a:ext cx="1440" cy="172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520" bIns="-295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7" name=""/>
            <p:cNvSpPr/>
            <p:nvPr/>
          </p:nvSpPr>
          <p:spPr>
            <a:xfrm>
              <a:off x="2486160" y="2070000"/>
              <a:ext cx="8244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8" name=""/>
            <p:cNvSpPr/>
            <p:nvPr/>
          </p:nvSpPr>
          <p:spPr>
            <a:xfrm flipV="1">
              <a:off x="2852640" y="2152800"/>
              <a:ext cx="1800" cy="237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9" name=""/>
            <p:cNvSpPr/>
            <p:nvPr/>
          </p:nvSpPr>
          <p:spPr>
            <a:xfrm>
              <a:off x="2813040" y="2152800"/>
              <a:ext cx="8244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0" name=""/>
            <p:cNvSpPr/>
            <p:nvPr/>
          </p:nvSpPr>
          <p:spPr>
            <a:xfrm>
              <a:off x="2852640" y="2176560"/>
              <a:ext cx="1800" cy="252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0" bIns="-216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1" name=""/>
            <p:cNvSpPr/>
            <p:nvPr/>
          </p:nvSpPr>
          <p:spPr>
            <a:xfrm>
              <a:off x="2813040" y="2201760"/>
              <a:ext cx="8244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2" name=""/>
            <p:cNvSpPr/>
            <p:nvPr/>
          </p:nvSpPr>
          <p:spPr>
            <a:xfrm flipV="1">
              <a:off x="3016080" y="2095560"/>
              <a:ext cx="1800" cy="172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520" bIns="-295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3" name=""/>
            <p:cNvSpPr/>
            <p:nvPr/>
          </p:nvSpPr>
          <p:spPr>
            <a:xfrm>
              <a:off x="2976480" y="2095560"/>
              <a:ext cx="8280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4" name=""/>
            <p:cNvSpPr/>
            <p:nvPr/>
          </p:nvSpPr>
          <p:spPr>
            <a:xfrm>
              <a:off x="3016080" y="2112840"/>
              <a:ext cx="1800" cy="190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5" name=""/>
            <p:cNvSpPr/>
            <p:nvPr/>
          </p:nvSpPr>
          <p:spPr>
            <a:xfrm>
              <a:off x="2976480" y="2131920"/>
              <a:ext cx="8280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6" name=""/>
            <p:cNvSpPr/>
            <p:nvPr/>
          </p:nvSpPr>
          <p:spPr>
            <a:xfrm>
              <a:off x="2163600" y="1427040"/>
              <a:ext cx="1800" cy="9176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7" name=""/>
            <p:cNvSpPr/>
            <p:nvPr/>
          </p:nvSpPr>
          <p:spPr>
            <a:xfrm>
              <a:off x="2127240" y="2344680"/>
              <a:ext cx="3636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8" name=""/>
            <p:cNvSpPr/>
            <p:nvPr/>
          </p:nvSpPr>
          <p:spPr>
            <a:xfrm>
              <a:off x="2127240" y="1887480"/>
              <a:ext cx="3636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9" name=""/>
            <p:cNvSpPr/>
            <p:nvPr/>
          </p:nvSpPr>
          <p:spPr>
            <a:xfrm>
              <a:off x="2127240" y="1427040"/>
              <a:ext cx="3636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0" name=""/>
            <p:cNvSpPr/>
            <p:nvPr/>
          </p:nvSpPr>
          <p:spPr>
            <a:xfrm flipV="1">
              <a:off x="2163600" y="2338200"/>
              <a:ext cx="1143000" cy="61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680" bIns="-406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1" name=""/>
            <p:cNvSpPr/>
            <p:nvPr/>
          </p:nvSpPr>
          <p:spPr>
            <a:xfrm flipV="1">
              <a:off x="2163600" y="2344320"/>
              <a:ext cx="1800" cy="32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2" name=""/>
            <p:cNvSpPr/>
            <p:nvPr/>
          </p:nvSpPr>
          <p:spPr>
            <a:xfrm flipV="1">
              <a:off x="3219480" y="2344320"/>
              <a:ext cx="1440" cy="32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3" name=""/>
            <p:cNvSpPr/>
            <p:nvPr/>
          </p:nvSpPr>
          <p:spPr>
            <a:xfrm>
              <a:off x="2009880" y="227484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4" name=""/>
            <p:cNvSpPr/>
            <p:nvPr/>
          </p:nvSpPr>
          <p:spPr>
            <a:xfrm>
              <a:off x="1987200" y="183672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5" name=""/>
            <p:cNvSpPr/>
            <p:nvPr/>
          </p:nvSpPr>
          <p:spPr>
            <a:xfrm>
              <a:off x="1996920" y="138744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2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6" name=""/>
            <p:cNvSpPr/>
            <p:nvPr/>
          </p:nvSpPr>
          <p:spPr>
            <a:xfrm>
              <a:off x="3179880" y="2365200"/>
              <a:ext cx="8280" cy="15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" spc="-1" strike="noStrike">
                  <a:solidFill>
                    <a:srgbClr val="000000"/>
                  </a:solidFill>
                  <a:latin typeface="Verdana"/>
                </a:rPr>
                <a:t>1</a:t>
              </a:r>
              <a:endParaRPr b="0" lang="en-US" sz="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7" name=""/>
            <p:cNvSpPr/>
            <p:nvPr/>
          </p:nvSpPr>
          <p:spPr>
            <a:xfrm flipV="1">
              <a:off x="2857680" y="1942920"/>
              <a:ext cx="0" cy="152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8" name=""/>
            <p:cNvSpPr/>
            <p:nvPr/>
          </p:nvSpPr>
          <p:spPr>
            <a:xfrm flipV="1">
              <a:off x="3009960" y="1942920"/>
              <a:ext cx="0" cy="75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9" name=""/>
            <p:cNvSpPr/>
            <p:nvPr/>
          </p:nvSpPr>
          <p:spPr>
            <a:xfrm>
              <a:off x="2857680" y="1943280"/>
              <a:ext cx="1522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0" name=""/>
            <p:cNvSpPr/>
            <p:nvPr/>
          </p:nvSpPr>
          <p:spPr>
            <a:xfrm>
              <a:off x="2837160" y="1806480"/>
              <a:ext cx="220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1" name=""/>
            <p:cNvSpPr/>
            <p:nvPr/>
          </p:nvSpPr>
          <p:spPr>
            <a:xfrm>
              <a:off x="1631880" y="1101600"/>
              <a:ext cx="290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SimSun"/>
                </a:rPr>
                <a:t>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2" name=""/>
            <p:cNvSpPr/>
            <p:nvPr/>
          </p:nvSpPr>
          <p:spPr>
            <a:xfrm rot="16200000">
              <a:off x="1146600" y="1720080"/>
              <a:ext cx="11905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SimSun"/>
                </a:rPr>
                <a:t>CD25</a:t>
              </a:r>
              <a:r>
                <a:rPr b="0" lang="en-US" sz="800" spc="-1" strike="noStrike" baseline="30000">
                  <a:solidFill>
                    <a:srgbClr val="000000"/>
                  </a:solidFill>
                  <a:latin typeface="Arial"/>
                  <a:ea typeface="SimSun"/>
                </a:rPr>
                <a:t>+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SimSun"/>
                </a:rPr>
                <a:t>FoxP3</a:t>
              </a:r>
              <a:r>
                <a:rPr b="0" lang="en-US" sz="800" spc="-1" strike="noStrike" baseline="30000">
                  <a:solidFill>
                    <a:srgbClr val="000000"/>
                  </a:solidFill>
                  <a:latin typeface="Arial"/>
                  <a:ea typeface="SimSun"/>
                </a:rPr>
                <a:t>+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SimSun"/>
                </a:rPr>
                <a:t>CELL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SimSun"/>
                </a:rPr>
                <a:t>(%) IN CD4+ PBMCs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23" name=""/>
          <p:cNvSpPr/>
          <p:nvPr/>
        </p:nvSpPr>
        <p:spPr>
          <a:xfrm rot="18187800">
            <a:off x="4380120" y="2543760"/>
            <a:ext cx="723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SimSun"/>
              </a:rPr>
              <a:t>B6/Z(+)D(+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24" name=""/>
          <p:cNvGrpSpPr/>
          <p:nvPr/>
        </p:nvGrpSpPr>
        <p:grpSpPr>
          <a:xfrm>
            <a:off x="3525840" y="1063800"/>
            <a:ext cx="1738440" cy="1862640"/>
            <a:chOff x="3525840" y="1063800"/>
            <a:chExt cx="1738440" cy="1862640"/>
          </a:xfrm>
        </p:grpSpPr>
        <p:sp>
          <p:nvSpPr>
            <p:cNvPr id="225" name=""/>
            <p:cNvSpPr/>
            <p:nvPr/>
          </p:nvSpPr>
          <p:spPr>
            <a:xfrm>
              <a:off x="3531960" y="1063800"/>
              <a:ext cx="290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SimSun"/>
                </a:rPr>
                <a:t>B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6" name=""/>
            <p:cNvSpPr/>
            <p:nvPr/>
          </p:nvSpPr>
          <p:spPr>
            <a:xfrm>
              <a:off x="4165560" y="2135160"/>
              <a:ext cx="168480" cy="2221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7" name=""/>
            <p:cNvSpPr/>
            <p:nvPr/>
          </p:nvSpPr>
          <p:spPr>
            <a:xfrm>
              <a:off x="4159080" y="2128680"/>
              <a:ext cx="168480" cy="2224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8" name=""/>
            <p:cNvSpPr/>
            <p:nvPr/>
          </p:nvSpPr>
          <p:spPr>
            <a:xfrm>
              <a:off x="4334040" y="2198520"/>
              <a:ext cx="166680" cy="1587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9" name=""/>
            <p:cNvSpPr/>
            <p:nvPr/>
          </p:nvSpPr>
          <p:spPr>
            <a:xfrm>
              <a:off x="4327560" y="2192400"/>
              <a:ext cx="166680" cy="15876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0" name=""/>
            <p:cNvSpPr/>
            <p:nvPr/>
          </p:nvSpPr>
          <p:spPr>
            <a:xfrm>
              <a:off x="4835520" y="2259000"/>
              <a:ext cx="166680" cy="982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1" name=""/>
            <p:cNvSpPr/>
            <p:nvPr/>
          </p:nvSpPr>
          <p:spPr>
            <a:xfrm>
              <a:off x="4729320" y="2201760"/>
              <a:ext cx="166680" cy="1555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2" name=""/>
            <p:cNvSpPr/>
            <p:nvPr/>
          </p:nvSpPr>
          <p:spPr>
            <a:xfrm>
              <a:off x="4722840" y="2195640"/>
              <a:ext cx="168120" cy="15552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3" name=""/>
            <p:cNvSpPr/>
            <p:nvPr/>
          </p:nvSpPr>
          <p:spPr>
            <a:xfrm>
              <a:off x="4896000" y="2049480"/>
              <a:ext cx="168120" cy="3078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4" name=""/>
            <p:cNvSpPr/>
            <p:nvPr/>
          </p:nvSpPr>
          <p:spPr>
            <a:xfrm>
              <a:off x="4890960" y="2043000"/>
              <a:ext cx="166680" cy="30816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5" name=""/>
            <p:cNvSpPr/>
            <p:nvPr/>
          </p:nvSpPr>
          <p:spPr>
            <a:xfrm flipV="1">
              <a:off x="4241880" y="2115720"/>
              <a:ext cx="1440" cy="12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6" name=""/>
            <p:cNvSpPr/>
            <p:nvPr/>
          </p:nvSpPr>
          <p:spPr>
            <a:xfrm>
              <a:off x="4202280" y="2116080"/>
              <a:ext cx="8244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7" name=""/>
            <p:cNvSpPr/>
            <p:nvPr/>
          </p:nvSpPr>
          <p:spPr>
            <a:xfrm>
              <a:off x="4241880" y="2128680"/>
              <a:ext cx="1440" cy="144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400" bIns="-32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8" name=""/>
            <p:cNvSpPr/>
            <p:nvPr/>
          </p:nvSpPr>
          <p:spPr>
            <a:xfrm>
              <a:off x="4202280" y="2143080"/>
              <a:ext cx="8244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9" name=""/>
            <p:cNvSpPr/>
            <p:nvPr/>
          </p:nvSpPr>
          <p:spPr>
            <a:xfrm flipV="1">
              <a:off x="4408560" y="2182320"/>
              <a:ext cx="1440" cy="9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0" name=""/>
            <p:cNvSpPr/>
            <p:nvPr/>
          </p:nvSpPr>
          <p:spPr>
            <a:xfrm>
              <a:off x="4370400" y="2182680"/>
              <a:ext cx="8100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1" name=""/>
            <p:cNvSpPr/>
            <p:nvPr/>
          </p:nvSpPr>
          <p:spPr>
            <a:xfrm>
              <a:off x="4408560" y="2192400"/>
              <a:ext cx="1440" cy="93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2" name=""/>
            <p:cNvSpPr/>
            <p:nvPr/>
          </p:nvSpPr>
          <p:spPr>
            <a:xfrm>
              <a:off x="4370400" y="2201760"/>
              <a:ext cx="8100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3" name=""/>
            <p:cNvSpPr/>
            <p:nvPr/>
          </p:nvSpPr>
          <p:spPr>
            <a:xfrm flipV="1">
              <a:off x="4805280" y="2174760"/>
              <a:ext cx="1800" cy="208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4" name=""/>
            <p:cNvSpPr/>
            <p:nvPr/>
          </p:nvSpPr>
          <p:spPr>
            <a:xfrm>
              <a:off x="4765680" y="2174760"/>
              <a:ext cx="8244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5" name=""/>
            <p:cNvSpPr/>
            <p:nvPr/>
          </p:nvSpPr>
          <p:spPr>
            <a:xfrm>
              <a:off x="4805280" y="2195640"/>
              <a:ext cx="1800" cy="20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6" name=""/>
            <p:cNvSpPr/>
            <p:nvPr/>
          </p:nvSpPr>
          <p:spPr>
            <a:xfrm>
              <a:off x="4765680" y="2216160"/>
              <a:ext cx="8244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7" name=""/>
            <p:cNvSpPr/>
            <p:nvPr/>
          </p:nvSpPr>
          <p:spPr>
            <a:xfrm flipV="1">
              <a:off x="4971960" y="2015640"/>
              <a:ext cx="1800" cy="270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800" bIns="-19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8" name=""/>
            <p:cNvSpPr/>
            <p:nvPr/>
          </p:nvSpPr>
          <p:spPr>
            <a:xfrm>
              <a:off x="4932360" y="2016000"/>
              <a:ext cx="8244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9" name=""/>
            <p:cNvSpPr/>
            <p:nvPr/>
          </p:nvSpPr>
          <p:spPr>
            <a:xfrm>
              <a:off x="4971960" y="2043000"/>
              <a:ext cx="1800" cy="237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0" name=""/>
            <p:cNvSpPr/>
            <p:nvPr/>
          </p:nvSpPr>
          <p:spPr>
            <a:xfrm>
              <a:off x="4932360" y="2066760"/>
              <a:ext cx="8244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1" name=""/>
            <p:cNvSpPr/>
            <p:nvPr/>
          </p:nvSpPr>
          <p:spPr>
            <a:xfrm>
              <a:off x="4035600" y="1433520"/>
              <a:ext cx="1440" cy="9176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2" name=""/>
            <p:cNvSpPr/>
            <p:nvPr/>
          </p:nvSpPr>
          <p:spPr>
            <a:xfrm>
              <a:off x="3998880" y="2351160"/>
              <a:ext cx="3672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3" name=""/>
            <p:cNvSpPr/>
            <p:nvPr/>
          </p:nvSpPr>
          <p:spPr>
            <a:xfrm>
              <a:off x="3998880" y="1893960"/>
              <a:ext cx="3672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4" name=""/>
            <p:cNvSpPr/>
            <p:nvPr/>
          </p:nvSpPr>
          <p:spPr>
            <a:xfrm>
              <a:off x="3998880" y="1433520"/>
              <a:ext cx="3672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5" name=""/>
            <p:cNvSpPr/>
            <p:nvPr/>
          </p:nvSpPr>
          <p:spPr>
            <a:xfrm>
              <a:off x="4035600" y="2351160"/>
              <a:ext cx="12286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6" name=""/>
            <p:cNvSpPr/>
            <p:nvPr/>
          </p:nvSpPr>
          <p:spPr>
            <a:xfrm flipV="1">
              <a:off x="4035600" y="2350800"/>
              <a:ext cx="1440" cy="32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7" name=""/>
            <p:cNvSpPr/>
            <p:nvPr/>
          </p:nvSpPr>
          <p:spPr>
            <a:xfrm>
              <a:off x="3881520" y="230040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8" name=""/>
            <p:cNvSpPr/>
            <p:nvPr/>
          </p:nvSpPr>
          <p:spPr>
            <a:xfrm>
              <a:off x="3900600" y="185256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9" name=""/>
            <p:cNvSpPr/>
            <p:nvPr/>
          </p:nvSpPr>
          <p:spPr>
            <a:xfrm>
              <a:off x="3900600" y="139392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0" name=""/>
            <p:cNvSpPr/>
            <p:nvPr/>
          </p:nvSpPr>
          <p:spPr>
            <a:xfrm flipV="1">
              <a:off x="4395960" y="1949040"/>
              <a:ext cx="0" cy="152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1" name=""/>
            <p:cNvSpPr/>
            <p:nvPr/>
          </p:nvSpPr>
          <p:spPr>
            <a:xfrm flipV="1">
              <a:off x="4243320" y="1949400"/>
              <a:ext cx="0" cy="76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2" name=""/>
            <p:cNvSpPr/>
            <p:nvPr/>
          </p:nvSpPr>
          <p:spPr>
            <a:xfrm>
              <a:off x="4243320" y="1949400"/>
              <a:ext cx="152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3" name=""/>
            <p:cNvSpPr/>
            <p:nvPr/>
          </p:nvSpPr>
          <p:spPr>
            <a:xfrm>
              <a:off x="4172040" y="1812960"/>
              <a:ext cx="299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***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4" name=""/>
            <p:cNvSpPr/>
            <p:nvPr/>
          </p:nvSpPr>
          <p:spPr>
            <a:xfrm flipV="1">
              <a:off x="4811760" y="1872720"/>
              <a:ext cx="0" cy="2286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5" name=""/>
            <p:cNvSpPr/>
            <p:nvPr/>
          </p:nvSpPr>
          <p:spPr>
            <a:xfrm flipV="1">
              <a:off x="4964040" y="1873080"/>
              <a:ext cx="0" cy="76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6" name=""/>
            <p:cNvSpPr/>
            <p:nvPr/>
          </p:nvSpPr>
          <p:spPr>
            <a:xfrm>
              <a:off x="4807080" y="1873080"/>
              <a:ext cx="1522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7" name=""/>
            <p:cNvSpPr/>
            <p:nvPr/>
          </p:nvSpPr>
          <p:spPr>
            <a:xfrm>
              <a:off x="4734000" y="1746360"/>
              <a:ext cx="299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***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8" name=""/>
            <p:cNvSpPr/>
            <p:nvPr/>
          </p:nvSpPr>
          <p:spPr>
            <a:xfrm rot="18182400">
              <a:off x="3862440" y="2478240"/>
              <a:ext cx="671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SimSun"/>
                </a:rPr>
                <a:t>B6/Z(-)D(-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9" name=""/>
            <p:cNvSpPr/>
            <p:nvPr/>
          </p:nvSpPr>
          <p:spPr>
            <a:xfrm rot="16200000">
              <a:off x="3139920" y="1698840"/>
              <a:ext cx="11088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SimSun"/>
                </a:rPr>
                <a:t>IL-17+IFN-</a:t>
              </a:r>
              <a:r>
                <a:rPr b="0" lang="en-US" sz="8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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SimSun"/>
                </a:rPr>
                <a:t> CELLS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SimSun"/>
                </a:rPr>
                <a:t>(% IN CD4+PBMCs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70" name=""/>
          <p:cNvGrpSpPr/>
          <p:nvPr/>
        </p:nvGrpSpPr>
        <p:grpSpPr>
          <a:xfrm>
            <a:off x="5087880" y="1081080"/>
            <a:ext cx="1744560" cy="1932480"/>
            <a:chOff x="5087880" y="1081080"/>
            <a:chExt cx="1744560" cy="1932480"/>
          </a:xfrm>
        </p:grpSpPr>
        <p:sp>
          <p:nvSpPr>
            <p:cNvPr id="271" name=""/>
            <p:cNvSpPr/>
            <p:nvPr/>
          </p:nvSpPr>
          <p:spPr>
            <a:xfrm>
              <a:off x="5503680" y="1081080"/>
              <a:ext cx="290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SimSun"/>
                </a:rPr>
                <a:t>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2" name=""/>
            <p:cNvSpPr/>
            <p:nvPr/>
          </p:nvSpPr>
          <p:spPr>
            <a:xfrm>
              <a:off x="5087880" y="2371680"/>
              <a:ext cx="8280" cy="15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" spc="-1" strike="noStrike">
                  <a:solidFill>
                    <a:srgbClr val="000000"/>
                  </a:solidFill>
                  <a:latin typeface="Verdana"/>
                </a:rPr>
                <a:t>1</a:t>
              </a:r>
              <a:endParaRPr b="0" lang="en-US" sz="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3" name=""/>
            <p:cNvSpPr/>
            <p:nvPr/>
          </p:nvSpPr>
          <p:spPr>
            <a:xfrm>
              <a:off x="5829480" y="2120760"/>
              <a:ext cx="145800" cy="2286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4" name=""/>
            <p:cNvSpPr/>
            <p:nvPr/>
          </p:nvSpPr>
          <p:spPr>
            <a:xfrm>
              <a:off x="5823000" y="2116080"/>
              <a:ext cx="146160" cy="22716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5" name=""/>
            <p:cNvSpPr/>
            <p:nvPr/>
          </p:nvSpPr>
          <p:spPr>
            <a:xfrm>
              <a:off x="5975280" y="2084400"/>
              <a:ext cx="146160" cy="2649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6" name=""/>
            <p:cNvSpPr/>
            <p:nvPr/>
          </p:nvSpPr>
          <p:spPr>
            <a:xfrm>
              <a:off x="5969160" y="2079720"/>
              <a:ext cx="145800" cy="26352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7" name=""/>
            <p:cNvSpPr/>
            <p:nvPr/>
          </p:nvSpPr>
          <p:spPr>
            <a:xfrm>
              <a:off x="6338880" y="2193840"/>
              <a:ext cx="146160" cy="1555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8" name=""/>
            <p:cNvSpPr/>
            <p:nvPr/>
          </p:nvSpPr>
          <p:spPr>
            <a:xfrm>
              <a:off x="6334200" y="2189160"/>
              <a:ext cx="144360" cy="1540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9" name=""/>
            <p:cNvSpPr/>
            <p:nvPr/>
          </p:nvSpPr>
          <p:spPr>
            <a:xfrm>
              <a:off x="6485040" y="2239920"/>
              <a:ext cx="145800" cy="1094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0" name=""/>
            <p:cNvSpPr/>
            <p:nvPr/>
          </p:nvSpPr>
          <p:spPr>
            <a:xfrm>
              <a:off x="6478560" y="2233440"/>
              <a:ext cx="146160" cy="10980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1" name=""/>
            <p:cNvSpPr/>
            <p:nvPr/>
          </p:nvSpPr>
          <p:spPr>
            <a:xfrm flipV="1">
              <a:off x="5896080" y="2084400"/>
              <a:ext cx="1440" cy="31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2" name=""/>
            <p:cNvSpPr/>
            <p:nvPr/>
          </p:nvSpPr>
          <p:spPr>
            <a:xfrm>
              <a:off x="5856120" y="2084400"/>
              <a:ext cx="8280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3" name=""/>
            <p:cNvSpPr/>
            <p:nvPr/>
          </p:nvSpPr>
          <p:spPr>
            <a:xfrm>
              <a:off x="5896080" y="2116080"/>
              <a:ext cx="1440" cy="270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800" bIns="-19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4" name=""/>
            <p:cNvSpPr/>
            <p:nvPr/>
          </p:nvSpPr>
          <p:spPr>
            <a:xfrm>
              <a:off x="5856120" y="2143080"/>
              <a:ext cx="8280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5" name=""/>
            <p:cNvSpPr/>
            <p:nvPr/>
          </p:nvSpPr>
          <p:spPr>
            <a:xfrm flipV="1">
              <a:off x="6041880" y="2073240"/>
              <a:ext cx="1800" cy="64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6" name=""/>
            <p:cNvSpPr/>
            <p:nvPr/>
          </p:nvSpPr>
          <p:spPr>
            <a:xfrm>
              <a:off x="6002280" y="2073240"/>
              <a:ext cx="8244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7" name=""/>
            <p:cNvSpPr/>
            <p:nvPr/>
          </p:nvSpPr>
          <p:spPr>
            <a:xfrm>
              <a:off x="6041880" y="2079720"/>
              <a:ext cx="180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8" name=""/>
            <p:cNvSpPr/>
            <p:nvPr/>
          </p:nvSpPr>
          <p:spPr>
            <a:xfrm>
              <a:off x="6002280" y="2081160"/>
              <a:ext cx="8244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9" name=""/>
            <p:cNvSpPr/>
            <p:nvPr/>
          </p:nvSpPr>
          <p:spPr>
            <a:xfrm flipV="1">
              <a:off x="6405480" y="2166840"/>
              <a:ext cx="1800" cy="223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0" name=""/>
            <p:cNvSpPr/>
            <p:nvPr/>
          </p:nvSpPr>
          <p:spPr>
            <a:xfrm>
              <a:off x="6367320" y="2166840"/>
              <a:ext cx="8100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1" name=""/>
            <p:cNvSpPr/>
            <p:nvPr/>
          </p:nvSpPr>
          <p:spPr>
            <a:xfrm>
              <a:off x="6405480" y="2189160"/>
              <a:ext cx="1800" cy="20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2" name=""/>
            <p:cNvSpPr/>
            <p:nvPr/>
          </p:nvSpPr>
          <p:spPr>
            <a:xfrm>
              <a:off x="6367320" y="2209680"/>
              <a:ext cx="8100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3" name=""/>
            <p:cNvSpPr/>
            <p:nvPr/>
          </p:nvSpPr>
          <p:spPr>
            <a:xfrm flipV="1">
              <a:off x="6551640" y="2225520"/>
              <a:ext cx="1440" cy="79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4" name=""/>
            <p:cNvSpPr/>
            <p:nvPr/>
          </p:nvSpPr>
          <p:spPr>
            <a:xfrm>
              <a:off x="6513480" y="2225520"/>
              <a:ext cx="8100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5" name=""/>
            <p:cNvSpPr/>
            <p:nvPr/>
          </p:nvSpPr>
          <p:spPr>
            <a:xfrm>
              <a:off x="6551640" y="2233440"/>
              <a:ext cx="1440" cy="64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6" name=""/>
            <p:cNvSpPr/>
            <p:nvPr/>
          </p:nvSpPr>
          <p:spPr>
            <a:xfrm>
              <a:off x="6513480" y="2239920"/>
              <a:ext cx="8100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7" name=""/>
            <p:cNvSpPr/>
            <p:nvPr/>
          </p:nvSpPr>
          <p:spPr>
            <a:xfrm>
              <a:off x="5713560" y="1476360"/>
              <a:ext cx="1440" cy="8668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8" name=""/>
            <p:cNvSpPr/>
            <p:nvPr/>
          </p:nvSpPr>
          <p:spPr>
            <a:xfrm>
              <a:off x="5670720" y="2343240"/>
              <a:ext cx="4284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9" name=""/>
            <p:cNvSpPr/>
            <p:nvPr/>
          </p:nvSpPr>
          <p:spPr>
            <a:xfrm>
              <a:off x="5670720" y="1911240"/>
              <a:ext cx="4284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0" name=""/>
            <p:cNvSpPr/>
            <p:nvPr/>
          </p:nvSpPr>
          <p:spPr>
            <a:xfrm>
              <a:off x="5670720" y="1476360"/>
              <a:ext cx="4284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1" name=""/>
            <p:cNvSpPr/>
            <p:nvPr/>
          </p:nvSpPr>
          <p:spPr>
            <a:xfrm>
              <a:off x="5713560" y="2343240"/>
              <a:ext cx="111888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2" name=""/>
            <p:cNvSpPr/>
            <p:nvPr/>
          </p:nvSpPr>
          <p:spPr>
            <a:xfrm flipV="1">
              <a:off x="5713560" y="2342880"/>
              <a:ext cx="1440" cy="32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3" name=""/>
            <p:cNvSpPr/>
            <p:nvPr/>
          </p:nvSpPr>
          <p:spPr>
            <a:xfrm flipV="1">
              <a:off x="6734160" y="2342880"/>
              <a:ext cx="1440" cy="32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4" name=""/>
            <p:cNvSpPr/>
            <p:nvPr/>
          </p:nvSpPr>
          <p:spPr>
            <a:xfrm>
              <a:off x="5522760" y="2268360"/>
              <a:ext cx="5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Verdana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5" name=""/>
            <p:cNvSpPr/>
            <p:nvPr/>
          </p:nvSpPr>
          <p:spPr>
            <a:xfrm>
              <a:off x="5520960" y="183672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Verdana"/>
                </a:rPr>
                <a:t>1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6" name=""/>
            <p:cNvSpPr/>
            <p:nvPr/>
          </p:nvSpPr>
          <p:spPr>
            <a:xfrm>
              <a:off x="5530320" y="143028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Verdana"/>
                </a:rPr>
                <a:t>2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7" name=""/>
            <p:cNvSpPr/>
            <p:nvPr/>
          </p:nvSpPr>
          <p:spPr>
            <a:xfrm>
              <a:off x="6418440" y="2365200"/>
              <a:ext cx="8280" cy="15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" spc="-1" strike="noStrike">
                  <a:solidFill>
                    <a:srgbClr val="000000"/>
                  </a:solidFill>
                  <a:latin typeface="Verdana"/>
                </a:rPr>
                <a:t>1</a:t>
              </a:r>
              <a:endParaRPr b="0" lang="en-US" sz="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8" name=""/>
            <p:cNvSpPr/>
            <p:nvPr/>
          </p:nvSpPr>
          <p:spPr>
            <a:xfrm flipV="1">
              <a:off x="6575400" y="1985760"/>
              <a:ext cx="0" cy="152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9" name=""/>
            <p:cNvSpPr/>
            <p:nvPr/>
          </p:nvSpPr>
          <p:spPr>
            <a:xfrm flipV="1">
              <a:off x="6423120" y="1985760"/>
              <a:ext cx="0" cy="75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0" name=""/>
            <p:cNvSpPr/>
            <p:nvPr/>
          </p:nvSpPr>
          <p:spPr>
            <a:xfrm>
              <a:off x="6423120" y="1986120"/>
              <a:ext cx="1522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1" name=""/>
            <p:cNvSpPr/>
            <p:nvPr/>
          </p:nvSpPr>
          <p:spPr>
            <a:xfrm>
              <a:off x="6363000" y="1868400"/>
              <a:ext cx="299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***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2" name=""/>
            <p:cNvSpPr/>
            <p:nvPr/>
          </p:nvSpPr>
          <p:spPr>
            <a:xfrm rot="18182400">
              <a:off x="5452920" y="2454120"/>
              <a:ext cx="671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SimSun"/>
                </a:rPr>
                <a:t>B6/Z(-)D(-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3" name=""/>
            <p:cNvSpPr/>
            <p:nvPr/>
          </p:nvSpPr>
          <p:spPr>
            <a:xfrm rot="18187800">
              <a:off x="5945400" y="2543760"/>
              <a:ext cx="723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SimSun"/>
                </a:rPr>
                <a:t>B6/Z(+)D(+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4" name=""/>
            <p:cNvSpPr/>
            <p:nvPr/>
          </p:nvSpPr>
          <p:spPr>
            <a:xfrm rot="16200000">
              <a:off x="5083200" y="1848600"/>
              <a:ext cx="650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SimSun"/>
                </a:rPr>
                <a:t>Treg/Th1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15" name="Picture 7" descr=""/>
          <p:cNvPicPr/>
          <p:nvPr/>
        </p:nvPicPr>
        <p:blipFill>
          <a:blip r:embed="rId1"/>
          <a:srcRect l="12931" t="14241" r="8075" b="5039"/>
          <a:stretch/>
        </p:blipFill>
        <p:spPr>
          <a:xfrm>
            <a:off x="1295280" y="1447920"/>
            <a:ext cx="2057400" cy="16761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316" name="Freeform 7"/>
          <p:cNvSpPr/>
          <p:nvPr/>
        </p:nvSpPr>
        <p:spPr>
          <a:xfrm>
            <a:off x="1440000" y="2516040"/>
            <a:ext cx="1060200" cy="574920"/>
          </a:xfrm>
          <a:prstGeom prst="pie">
            <a:avLst/>
          </a:prstGeom>
          <a:noFill/>
          <a:ln w="38160">
            <a:solidFill>
              <a:srgbClr val="bbe0e3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7" name="Rectangle 8"/>
          <p:cNvSpPr/>
          <p:nvPr/>
        </p:nvSpPr>
        <p:spPr>
          <a:xfrm>
            <a:off x="2219400" y="1508040"/>
            <a:ext cx="784080" cy="59076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8" name="Rectangle 9"/>
          <p:cNvSpPr/>
          <p:nvPr/>
        </p:nvSpPr>
        <p:spPr>
          <a:xfrm>
            <a:off x="1731960" y="2343240"/>
            <a:ext cx="784080" cy="59220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19" name="Picture 10" descr=""/>
          <p:cNvPicPr/>
          <p:nvPr/>
        </p:nvPicPr>
        <p:blipFill>
          <a:blip r:embed="rId2"/>
          <a:srcRect l="14821" t="14286" r="7402" b="4769"/>
          <a:stretch/>
        </p:blipFill>
        <p:spPr>
          <a:xfrm>
            <a:off x="3429000" y="1459080"/>
            <a:ext cx="2057400" cy="16650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320" name="Picture 11" descr=""/>
          <p:cNvPicPr/>
          <p:nvPr/>
        </p:nvPicPr>
        <p:blipFill>
          <a:blip r:embed="rId3"/>
          <a:srcRect l="0" t="18813" r="22222" b="0"/>
          <a:stretch/>
        </p:blipFill>
        <p:spPr>
          <a:xfrm>
            <a:off x="5562720" y="1459080"/>
            <a:ext cx="2057400" cy="16650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321" name="TextBox 15"/>
          <p:cNvSpPr/>
          <p:nvPr/>
        </p:nvSpPr>
        <p:spPr>
          <a:xfrm>
            <a:off x="1219320" y="1447920"/>
            <a:ext cx="457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2" name="TextBox 16"/>
          <p:cNvSpPr/>
          <p:nvPr/>
        </p:nvSpPr>
        <p:spPr>
          <a:xfrm>
            <a:off x="3352680" y="1447920"/>
            <a:ext cx="457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3" name="TextBox 17"/>
          <p:cNvSpPr/>
          <p:nvPr/>
        </p:nvSpPr>
        <p:spPr>
          <a:xfrm>
            <a:off x="5486400" y="1447920"/>
            <a:ext cx="457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4" name="Rectangle 19"/>
          <p:cNvSpPr/>
          <p:nvPr/>
        </p:nvSpPr>
        <p:spPr>
          <a:xfrm>
            <a:off x="3962520" y="2286000"/>
            <a:ext cx="314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400" spc="-1" strike="noStrike">
                <a:solidFill>
                  <a:srgbClr val="000000"/>
                </a:solidFill>
                <a:latin typeface="Century"/>
                <a:ea typeface="Arial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5" name="Rectangle 20"/>
          <p:cNvSpPr/>
          <p:nvPr/>
        </p:nvSpPr>
        <p:spPr>
          <a:xfrm>
            <a:off x="6957720" y="2819520"/>
            <a:ext cx="384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400" spc="-1" strike="noStrike">
                <a:solidFill>
                  <a:srgbClr val="000000"/>
                </a:solidFill>
                <a:latin typeface="Century"/>
                <a:ea typeface="Arial"/>
              </a:rPr>
              <a:t>C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6" name="Rectangle 21"/>
          <p:cNvSpPr/>
          <p:nvPr/>
        </p:nvSpPr>
        <p:spPr>
          <a:xfrm>
            <a:off x="6187680" y="1828800"/>
            <a:ext cx="426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400" spc="-1" strike="noStrike">
                <a:solidFill>
                  <a:srgbClr val="000000"/>
                </a:solidFill>
                <a:latin typeface="Century"/>
                <a:ea typeface="Arial"/>
              </a:rPr>
              <a:t>N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7" name="TextBox 16"/>
          <p:cNvSpPr/>
          <p:nvPr/>
        </p:nvSpPr>
        <p:spPr>
          <a:xfrm>
            <a:off x="1600200" y="2316240"/>
            <a:ext cx="457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8" name="TextBox 16"/>
          <p:cNvSpPr/>
          <p:nvPr/>
        </p:nvSpPr>
        <p:spPr>
          <a:xfrm>
            <a:off x="2108160" y="1490760"/>
            <a:ext cx="457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9" name="Rectangle 18"/>
          <p:cNvSpPr/>
          <p:nvPr/>
        </p:nvSpPr>
        <p:spPr>
          <a:xfrm>
            <a:off x="1219320" y="3295800"/>
            <a:ext cx="6657840" cy="1037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Supplementary Figure 3: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Histological images of extraction sockets of C57BL/6 mice after treatment with Zometa and Dex for 12 weeks. (A) Presence of area of uncovered mucosal epithelial lining (original magnification : x4). (B) Irregular pattern of bone formation among fibrous tissues (original magnification : x10). (C) Necrotic bone area (original magnification : x10). (</a:t>
            </a:r>
            <a:r>
              <a:rPr b="1" i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B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: newly formed bone, </a:t>
            </a:r>
            <a:r>
              <a:rPr b="1" i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CT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: connective tissue, </a:t>
            </a:r>
            <a:r>
              <a:rPr b="1" i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NB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: necrotic bone). The results were representative of three independent experiments</a:t>
            </a:r>
            <a:r>
              <a:rPr b="0" lang="en-US" sz="1400" spc="-1" strike="noStrike">
                <a:solidFill>
                  <a:srgbClr val="000000"/>
                </a:solidFill>
                <a:latin typeface="Century"/>
                <a:ea typeface="Arial"/>
              </a:rPr>
              <a:t>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30" name="Picture 2" descr=""/>
          <p:cNvPicPr/>
          <p:nvPr/>
        </p:nvPicPr>
        <p:blipFill>
          <a:blip r:embed="rId1"/>
          <a:stretch/>
        </p:blipFill>
        <p:spPr>
          <a:xfrm>
            <a:off x="1657440" y="2166840"/>
            <a:ext cx="1903320" cy="14335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331" name="Picture 3" descr=""/>
          <p:cNvPicPr/>
          <p:nvPr/>
        </p:nvPicPr>
        <p:blipFill>
          <a:blip r:embed="rId2"/>
          <a:stretch/>
        </p:blipFill>
        <p:spPr>
          <a:xfrm>
            <a:off x="3619440" y="2149560"/>
            <a:ext cx="1914480" cy="14428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332" name="Picture 5" descr=""/>
          <p:cNvPicPr/>
          <p:nvPr/>
        </p:nvPicPr>
        <p:blipFill>
          <a:blip r:embed="rId3"/>
          <a:stretch/>
        </p:blipFill>
        <p:spPr>
          <a:xfrm>
            <a:off x="5591160" y="2139840"/>
            <a:ext cx="1925640" cy="14511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333" name="Picture 6" descr=""/>
          <p:cNvPicPr/>
          <p:nvPr/>
        </p:nvPicPr>
        <p:blipFill>
          <a:blip r:embed="rId4"/>
          <a:stretch/>
        </p:blipFill>
        <p:spPr>
          <a:xfrm>
            <a:off x="1644480" y="657360"/>
            <a:ext cx="1920960" cy="14475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334" name="Picture 7" descr=""/>
          <p:cNvPicPr/>
          <p:nvPr/>
        </p:nvPicPr>
        <p:blipFill>
          <a:blip r:embed="rId5"/>
          <a:stretch/>
        </p:blipFill>
        <p:spPr>
          <a:xfrm>
            <a:off x="3619440" y="644400"/>
            <a:ext cx="1925640" cy="14511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335" name="Picture 8" descr=""/>
          <p:cNvPicPr/>
          <p:nvPr/>
        </p:nvPicPr>
        <p:blipFill>
          <a:blip r:embed="rId6"/>
          <a:stretch/>
        </p:blipFill>
        <p:spPr>
          <a:xfrm>
            <a:off x="5591160" y="644400"/>
            <a:ext cx="1925640" cy="14511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336" name="TextBox 15"/>
          <p:cNvSpPr/>
          <p:nvPr/>
        </p:nvSpPr>
        <p:spPr>
          <a:xfrm>
            <a:off x="1650960" y="663480"/>
            <a:ext cx="343080" cy="3682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7" name="Rectangle 11"/>
          <p:cNvSpPr/>
          <p:nvPr/>
        </p:nvSpPr>
        <p:spPr>
          <a:xfrm>
            <a:off x="1990800" y="714240"/>
            <a:ext cx="857160" cy="6192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8" name="TextBox 16"/>
          <p:cNvSpPr/>
          <p:nvPr/>
        </p:nvSpPr>
        <p:spPr>
          <a:xfrm>
            <a:off x="1866960" y="666720"/>
            <a:ext cx="457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9" name="Rectangle 13"/>
          <p:cNvSpPr/>
          <p:nvPr/>
        </p:nvSpPr>
        <p:spPr>
          <a:xfrm>
            <a:off x="2685960" y="933480"/>
            <a:ext cx="857520" cy="619200"/>
          </a:xfrm>
          <a:prstGeom prst="rect">
            <a:avLst/>
          </a:prstGeom>
          <a:noFill/>
          <a:ln w="12600">
            <a:solidFill>
              <a:srgbClr val="ffff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0" name="TextBox 16"/>
          <p:cNvSpPr/>
          <p:nvPr/>
        </p:nvSpPr>
        <p:spPr>
          <a:xfrm>
            <a:off x="3171960" y="895320"/>
            <a:ext cx="457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1" name="Rectangle 18"/>
          <p:cNvSpPr/>
          <p:nvPr/>
        </p:nvSpPr>
        <p:spPr>
          <a:xfrm>
            <a:off x="1952640" y="2162160"/>
            <a:ext cx="857160" cy="6192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2" name="Rectangle 19"/>
          <p:cNvSpPr/>
          <p:nvPr/>
        </p:nvSpPr>
        <p:spPr>
          <a:xfrm>
            <a:off x="2676600" y="2286000"/>
            <a:ext cx="857160" cy="619200"/>
          </a:xfrm>
          <a:prstGeom prst="rect">
            <a:avLst/>
          </a:prstGeom>
          <a:noFill/>
          <a:ln w="12600">
            <a:solidFill>
              <a:srgbClr val="ffff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3" name="TextBox 16"/>
          <p:cNvSpPr/>
          <p:nvPr/>
        </p:nvSpPr>
        <p:spPr>
          <a:xfrm>
            <a:off x="1847880" y="2124000"/>
            <a:ext cx="457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4" name="TextBox 16"/>
          <p:cNvSpPr/>
          <p:nvPr/>
        </p:nvSpPr>
        <p:spPr>
          <a:xfrm>
            <a:off x="3152880" y="2352600"/>
            <a:ext cx="457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F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5" name="TextBox 22"/>
          <p:cNvSpPr/>
          <p:nvPr/>
        </p:nvSpPr>
        <p:spPr>
          <a:xfrm>
            <a:off x="3914640" y="136224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N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6" name="TextBox 23"/>
          <p:cNvSpPr/>
          <p:nvPr/>
        </p:nvSpPr>
        <p:spPr>
          <a:xfrm>
            <a:off x="4610160" y="116208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BF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7" name="TextBox 24"/>
          <p:cNvSpPr/>
          <p:nvPr/>
        </p:nvSpPr>
        <p:spPr>
          <a:xfrm>
            <a:off x="6296040" y="81900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BF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8" name="TextBox 25"/>
          <p:cNvSpPr/>
          <p:nvPr/>
        </p:nvSpPr>
        <p:spPr>
          <a:xfrm>
            <a:off x="6581880" y="1581120"/>
            <a:ext cx="533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N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9" name="TextBox 26"/>
          <p:cNvSpPr/>
          <p:nvPr/>
        </p:nvSpPr>
        <p:spPr>
          <a:xfrm>
            <a:off x="6429240" y="262908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N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0" name="TextBox 27"/>
          <p:cNvSpPr/>
          <p:nvPr/>
        </p:nvSpPr>
        <p:spPr>
          <a:xfrm>
            <a:off x="5772240" y="2886120"/>
            <a:ext cx="533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BF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1" name="TextBox 29"/>
          <p:cNvSpPr/>
          <p:nvPr/>
        </p:nvSpPr>
        <p:spPr>
          <a:xfrm>
            <a:off x="4067280" y="3162240"/>
            <a:ext cx="533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N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2" name="TextBox 31"/>
          <p:cNvSpPr/>
          <p:nvPr/>
        </p:nvSpPr>
        <p:spPr>
          <a:xfrm>
            <a:off x="571680" y="1181160"/>
            <a:ext cx="1047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2 week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3" name="TextBox 32"/>
          <p:cNvSpPr/>
          <p:nvPr/>
        </p:nvSpPr>
        <p:spPr>
          <a:xfrm>
            <a:off x="600120" y="2666880"/>
            <a:ext cx="1047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7 week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4" name="TextBox 15"/>
          <p:cNvSpPr/>
          <p:nvPr/>
        </p:nvSpPr>
        <p:spPr>
          <a:xfrm>
            <a:off x="3632040" y="650880"/>
            <a:ext cx="343080" cy="3682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5" name="TextBox 15"/>
          <p:cNvSpPr/>
          <p:nvPr/>
        </p:nvSpPr>
        <p:spPr>
          <a:xfrm>
            <a:off x="5587920" y="650880"/>
            <a:ext cx="343080" cy="3682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6" name="TextBox 15"/>
          <p:cNvSpPr/>
          <p:nvPr/>
        </p:nvSpPr>
        <p:spPr>
          <a:xfrm>
            <a:off x="1650960" y="2174760"/>
            <a:ext cx="343080" cy="3682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7" name="TextBox 15"/>
          <p:cNvSpPr/>
          <p:nvPr/>
        </p:nvSpPr>
        <p:spPr>
          <a:xfrm>
            <a:off x="3632040" y="2149560"/>
            <a:ext cx="343080" cy="3682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8" name="TextBox 15"/>
          <p:cNvSpPr/>
          <p:nvPr/>
        </p:nvSpPr>
        <p:spPr>
          <a:xfrm>
            <a:off x="5600880" y="2149560"/>
            <a:ext cx="342720" cy="3682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9" name="Rectangle 30"/>
          <p:cNvSpPr/>
          <p:nvPr/>
        </p:nvSpPr>
        <p:spPr>
          <a:xfrm>
            <a:off x="1562040" y="3708360"/>
            <a:ext cx="619128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Supplementary Figure 4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Presence of microbial biofilm colonization at necrotic extraction sockets of wild type C57/BL6 mice at 2 weeks (A:10X; B and C: 20X), and 7 weeks (D:10X; E and F: 20X) post-surgical extraction; B and E represent black inserts; C and F represent yellow inserts. </a:t>
            </a:r>
            <a:r>
              <a:rPr b="1" i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NB,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n ecrotic bone; </a:t>
            </a:r>
            <a:r>
              <a:rPr b="1" i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BF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, biofilm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95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3-22T17:49:10Z</dcterms:created>
  <dc:creator>Songtao Shi</dc:creator>
  <dc:description/>
  <dc:language>en-US</dc:language>
  <cp:lastModifiedBy>Sonjtao Shi</cp:lastModifiedBy>
  <cp:lastPrinted>2009-06-16T18:59:03Z</cp:lastPrinted>
  <dcterms:modified xsi:type="dcterms:W3CDTF">2009-11-19T00:54:20Z</dcterms:modified>
  <cp:revision>228</cp:revision>
  <dc:subject/>
  <dc:title>PowerPoint Presentation</dc:title>
</cp:coreProperties>
</file>